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6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432C8503-C43E-94CC-6B2A-DAA1A4999F03}" name="Keane, Sean T" initials="SK" userId="S::skeane1@ic.ac.uk::4b207843-03b2-4fe5-b9e3-eab1bfb1e984" providerId="AD"/>
  <p188:author id="{25965566-DCB8-5FB7-0D4C-B52D2E943281}" name="Fulton, William T J" initials="FJ" userId="S::wfulton@ic.ac.uk::4d291324-378e-4ad8-aeb6-9357da62268d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C083E6E3-FA7D-4D7B-A595-EF9225AFEA82}" styleName="Light Style 1 –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103"/>
    <p:restoredTop sz="94682"/>
  </p:normalViewPr>
  <p:slideViewPr>
    <p:cSldViewPr snapToGrid="0">
      <p:cViewPr varScale="1">
        <p:scale>
          <a:sx n="82" d="100"/>
          <a:sy n="82" d="100"/>
        </p:scale>
        <p:origin x="3408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5A8D21F-E96E-B947-B1D5-044ED282B3F2}" type="datetimeFigureOut">
              <a:rPr lang="en-US" smtClean="0"/>
              <a:t>4/15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F503B47-3EBB-C14E-8E79-44CC56B811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51485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F503B47-3EBB-C14E-8E79-44CC56B8111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734028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467-1849-544D-9CB4-F81AC22A8BDD}" type="datetimeFigureOut">
              <a:rPr lang="en-US" smtClean="0"/>
              <a:t>4/1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92837-0CEC-E649-A1B3-5FE99A7DA0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08224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467-1849-544D-9CB4-F81AC22A8BDD}" type="datetimeFigureOut">
              <a:rPr lang="en-US" smtClean="0"/>
              <a:t>4/1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92837-0CEC-E649-A1B3-5FE99A7DA0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15635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467-1849-544D-9CB4-F81AC22A8BDD}" type="datetimeFigureOut">
              <a:rPr lang="en-US" smtClean="0"/>
              <a:t>4/1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92837-0CEC-E649-A1B3-5FE99A7DA0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6330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467-1849-544D-9CB4-F81AC22A8BDD}" type="datetimeFigureOut">
              <a:rPr lang="en-US" smtClean="0"/>
              <a:t>4/1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92837-0CEC-E649-A1B3-5FE99A7DA0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585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467-1849-544D-9CB4-F81AC22A8BDD}" type="datetimeFigureOut">
              <a:rPr lang="en-US" smtClean="0"/>
              <a:t>4/1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92837-0CEC-E649-A1B3-5FE99A7DA0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33061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467-1849-544D-9CB4-F81AC22A8BDD}" type="datetimeFigureOut">
              <a:rPr lang="en-US" smtClean="0"/>
              <a:t>4/15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92837-0CEC-E649-A1B3-5FE99A7DA0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61075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467-1849-544D-9CB4-F81AC22A8BDD}" type="datetimeFigureOut">
              <a:rPr lang="en-US" smtClean="0"/>
              <a:t>4/15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92837-0CEC-E649-A1B3-5FE99A7DA0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488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467-1849-544D-9CB4-F81AC22A8BDD}" type="datetimeFigureOut">
              <a:rPr lang="en-US" smtClean="0"/>
              <a:t>4/15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92837-0CEC-E649-A1B3-5FE99A7DA0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78455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467-1849-544D-9CB4-F81AC22A8BDD}" type="datetimeFigureOut">
              <a:rPr lang="en-US" smtClean="0"/>
              <a:t>4/15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92837-0CEC-E649-A1B3-5FE99A7DA0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69995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467-1849-544D-9CB4-F81AC22A8BDD}" type="datetimeFigureOut">
              <a:rPr lang="en-US" smtClean="0"/>
              <a:t>4/15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92837-0CEC-E649-A1B3-5FE99A7DA0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92066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467-1849-544D-9CB4-F81AC22A8BDD}" type="datetimeFigureOut">
              <a:rPr lang="en-US" smtClean="0"/>
              <a:t>4/15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92837-0CEC-E649-A1B3-5FE99A7DA0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44461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E9D467-1849-544D-9CB4-F81AC22A8BDD}" type="datetimeFigureOut">
              <a:rPr lang="en-US" smtClean="0"/>
              <a:t>4/1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D92837-0CEC-E649-A1B3-5FE99A7DA0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94467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1CE4807-2F64-1F04-5269-AA4D7A4A5F18}"/>
              </a:ext>
            </a:extLst>
          </p:cNvPr>
          <p:cNvSpPr txBox="1"/>
          <p:nvPr/>
        </p:nvSpPr>
        <p:spPr>
          <a:xfrm>
            <a:off x="0" y="9567446"/>
            <a:ext cx="23727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6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E11B8440-17AF-0295-F91D-6564238B3DF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3010" y="376670"/>
            <a:ext cx="6422081" cy="4860347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5900C4D0-A4E9-22AB-48C2-643319880E86}"/>
              </a:ext>
            </a:extLst>
          </p:cNvPr>
          <p:cNvSpPr/>
          <p:nvPr/>
        </p:nvSpPr>
        <p:spPr>
          <a:xfrm>
            <a:off x="1579419" y="2731325"/>
            <a:ext cx="1056903" cy="332509"/>
          </a:xfrm>
          <a:prstGeom prst="rect">
            <a:avLst/>
          </a:prstGeom>
          <a:solidFill>
            <a:schemeClr val="accent6">
              <a:lumMod val="20000"/>
              <a:lumOff val="80000"/>
              <a:alpha val="33841"/>
            </a:schemeClr>
          </a:solidFill>
          <a:ln>
            <a:solidFill>
              <a:srgbClr val="00B050"/>
            </a:solidFill>
            <a:prstDash val="solid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5C8A45F3-12BD-AF0B-4655-58DEE034B855}"/>
              </a:ext>
            </a:extLst>
          </p:cNvPr>
          <p:cNvSpPr/>
          <p:nvPr/>
        </p:nvSpPr>
        <p:spPr>
          <a:xfrm>
            <a:off x="1684318" y="1210603"/>
            <a:ext cx="1056903" cy="332509"/>
          </a:xfrm>
          <a:prstGeom prst="rect">
            <a:avLst/>
          </a:prstGeom>
          <a:solidFill>
            <a:schemeClr val="accent6">
              <a:lumMod val="20000"/>
              <a:lumOff val="80000"/>
              <a:alpha val="33841"/>
            </a:schemeClr>
          </a:solidFill>
          <a:ln>
            <a:solidFill>
              <a:srgbClr val="00B050"/>
            </a:solidFill>
            <a:prstDash val="solid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Oval 6">
            <a:extLst>
              <a:ext uri="{FF2B5EF4-FFF2-40B4-BE49-F238E27FC236}">
                <a16:creationId xmlns:a16="http://schemas.microsoft.com/office/drawing/2014/main" id="{F50C0EC5-0464-8150-98A1-CC9CAE88A9FA}"/>
              </a:ext>
            </a:extLst>
          </p:cNvPr>
          <p:cNvSpPr/>
          <p:nvPr/>
        </p:nvSpPr>
        <p:spPr>
          <a:xfrm>
            <a:off x="1257634" y="2719450"/>
            <a:ext cx="332509" cy="344384"/>
          </a:xfrm>
          <a:prstGeom prst="ellipse">
            <a:avLst/>
          </a:prstGeom>
          <a:solidFill>
            <a:schemeClr val="accent6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8" name="Oval 7">
            <a:extLst>
              <a:ext uri="{FF2B5EF4-FFF2-40B4-BE49-F238E27FC236}">
                <a16:creationId xmlns:a16="http://schemas.microsoft.com/office/drawing/2014/main" id="{14A0F500-6075-5C20-6DA2-E47628B1207C}"/>
              </a:ext>
            </a:extLst>
          </p:cNvPr>
          <p:cNvSpPr/>
          <p:nvPr/>
        </p:nvSpPr>
        <p:spPr>
          <a:xfrm>
            <a:off x="1376388" y="1197739"/>
            <a:ext cx="332509" cy="344384"/>
          </a:xfrm>
          <a:prstGeom prst="ellipse">
            <a:avLst/>
          </a:prstGeom>
          <a:solidFill>
            <a:schemeClr val="accent6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510ECB46-65BA-C166-9C63-D01D2182508C}"/>
              </a:ext>
            </a:extLst>
          </p:cNvPr>
          <p:cNvCxnSpPr/>
          <p:nvPr/>
        </p:nvCxnSpPr>
        <p:spPr>
          <a:xfrm>
            <a:off x="2636322" y="2891642"/>
            <a:ext cx="792678" cy="0"/>
          </a:xfrm>
          <a:prstGeom prst="line">
            <a:avLst/>
          </a:prstGeom>
          <a:ln>
            <a:solidFill>
              <a:schemeClr val="accent6">
                <a:lumMod val="50000"/>
              </a:schemeClr>
            </a:solidFill>
            <a:head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3CD66471-EBAC-7E95-B56B-F78C81EBAB38}"/>
              </a:ext>
            </a:extLst>
          </p:cNvPr>
          <p:cNvCxnSpPr>
            <a:cxnSpLocks/>
          </p:cNvCxnSpPr>
          <p:nvPr/>
        </p:nvCxnSpPr>
        <p:spPr>
          <a:xfrm flipH="1">
            <a:off x="3429000" y="1677784"/>
            <a:ext cx="1056903" cy="1213858"/>
          </a:xfrm>
          <a:prstGeom prst="line">
            <a:avLst/>
          </a:prstGeom>
          <a:ln>
            <a:solidFill>
              <a:schemeClr val="accent6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Rectangle 15">
            <a:extLst>
              <a:ext uri="{FF2B5EF4-FFF2-40B4-BE49-F238E27FC236}">
                <a16:creationId xmlns:a16="http://schemas.microsoft.com/office/drawing/2014/main" id="{96E5E8CA-9129-773C-BF67-3075CA6AF544}"/>
              </a:ext>
            </a:extLst>
          </p:cNvPr>
          <p:cNvSpPr/>
          <p:nvPr/>
        </p:nvSpPr>
        <p:spPr>
          <a:xfrm>
            <a:off x="4116781" y="1264596"/>
            <a:ext cx="2478209" cy="413188"/>
          </a:xfrm>
          <a:prstGeom prst="rect">
            <a:avLst/>
          </a:prstGeom>
          <a:solidFill>
            <a:schemeClr val="accent6">
              <a:lumMod val="20000"/>
              <a:lumOff val="80000"/>
              <a:alpha val="33841"/>
            </a:schemeClr>
          </a:solidFill>
          <a:ln>
            <a:solidFill>
              <a:srgbClr val="00B050"/>
            </a:solidFill>
            <a:prstDash val="solid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b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S = -1.76</a:t>
            </a:r>
          </a:p>
          <a:p>
            <a:pPr algn="ctr"/>
            <a:r>
              <a:rPr lang="en-US" sz="800" i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JAK1, PML, FASN, GATA3, CORO1A, PARP14, IL4R, TCF7, TUBA1B, HSP90AB1 </a:t>
            </a:r>
            <a:r>
              <a:rPr lang="en-US" sz="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800" i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EF1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AD13F32F-9C6B-45DD-47FD-D6A71DD98D4C}"/>
              </a:ext>
            </a:extLst>
          </p:cNvPr>
          <p:cNvSpPr/>
          <p:nvPr/>
        </p:nvSpPr>
        <p:spPr>
          <a:xfrm>
            <a:off x="3865123" y="447473"/>
            <a:ext cx="2729867" cy="680931"/>
          </a:xfrm>
          <a:prstGeom prst="rect">
            <a:avLst/>
          </a:prstGeom>
          <a:solidFill>
            <a:schemeClr val="accent6">
              <a:lumMod val="20000"/>
              <a:lumOff val="80000"/>
              <a:alpha val="33841"/>
            </a:schemeClr>
          </a:solidFill>
          <a:ln>
            <a:solidFill>
              <a:srgbClr val="00B050"/>
            </a:solidFill>
            <a:prstDash val="solid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b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S = 1.60</a:t>
            </a:r>
          </a:p>
          <a:p>
            <a:pPr algn="ctr"/>
            <a:r>
              <a:rPr lang="en-US" sz="800" i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2, IL1R1, HLA-A, HLA-DPB1, HLA-DRB1, PTPN22, NLRP6, PDCD1LG2, ARID5A, BTN3A2, HMGB1, GAS6, ISG15, CCR7, PDE4B, C1QBP, RIPK2, IRF8, PDE4D, ZP3, HAVCR2, </a:t>
            </a:r>
            <a:r>
              <a:rPr lang="en-US" sz="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800" i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LA-DPA1</a:t>
            </a: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506D1183-A486-575B-77B7-F23DC5AB4600}"/>
              </a:ext>
            </a:extLst>
          </p:cNvPr>
          <p:cNvCxnSpPr>
            <a:cxnSpLocks/>
          </p:cNvCxnSpPr>
          <p:nvPr/>
        </p:nvCxnSpPr>
        <p:spPr>
          <a:xfrm flipV="1">
            <a:off x="2548774" y="622570"/>
            <a:ext cx="343583" cy="575169"/>
          </a:xfrm>
          <a:prstGeom prst="line">
            <a:avLst/>
          </a:prstGeom>
          <a:ln>
            <a:solidFill>
              <a:schemeClr val="accent6">
                <a:lumMod val="50000"/>
              </a:schemeClr>
            </a:solidFill>
            <a:head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34485F05-23B1-A026-7A39-B5278A75E93D}"/>
              </a:ext>
            </a:extLst>
          </p:cNvPr>
          <p:cNvCxnSpPr>
            <a:cxnSpLocks/>
          </p:cNvCxnSpPr>
          <p:nvPr/>
        </p:nvCxnSpPr>
        <p:spPr>
          <a:xfrm flipH="1">
            <a:off x="2892357" y="622570"/>
            <a:ext cx="972766" cy="0"/>
          </a:xfrm>
          <a:prstGeom prst="line">
            <a:avLst/>
          </a:prstGeom>
          <a:ln>
            <a:solidFill>
              <a:schemeClr val="accent6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695813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4744</TotalTime>
  <Words>78</Words>
  <Application>Microsoft Macintosh PowerPoint</Application>
  <PresentationFormat>A4 Paper (210x297 mm)</PresentationFormat>
  <Paragraphs>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yhadi, Janice A</dc:creator>
  <cp:lastModifiedBy>Layhadi, Janice A</cp:lastModifiedBy>
  <cp:revision>41</cp:revision>
  <cp:lastPrinted>2023-09-27T12:15:59Z</cp:lastPrinted>
  <dcterms:created xsi:type="dcterms:W3CDTF">2023-09-26T16:40:01Z</dcterms:created>
  <dcterms:modified xsi:type="dcterms:W3CDTF">2025-04-15T06:44:09Z</dcterms:modified>
</cp:coreProperties>
</file>